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80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00"/>
    <a:srgbClr val="F74ED6"/>
    <a:srgbClr val="05BE78"/>
    <a:srgbClr val="FF8080"/>
    <a:srgbClr val="FFFFFF"/>
    <a:srgbClr val="0000FF"/>
    <a:srgbClr val="76069A"/>
    <a:srgbClr val="FF8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875"/>
    <p:restoredTop sz="94682"/>
  </p:normalViewPr>
  <p:slideViewPr>
    <p:cSldViewPr snapToGrid="0">
      <p:cViewPr varScale="1">
        <p:scale>
          <a:sx n="69" d="100"/>
          <a:sy n="69" d="100"/>
        </p:scale>
        <p:origin x="1788" y="84"/>
      </p:cViewPr>
      <p:guideLst>
        <p:guide orient="horz" pos="16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35" tIns="45718" rIns="91435" bIns="45718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35" tIns="45718" rIns="91435" bIns="45718" rtlCol="0"/>
          <a:lstStyle>
            <a:lvl1pPr algn="r">
              <a:defRPr sz="1200"/>
            </a:lvl1pPr>
          </a:lstStyle>
          <a:p>
            <a:fld id="{2781702D-12D0-4839-A3CC-B3169D578D6E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2225" y="1143000"/>
            <a:ext cx="17335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5" tIns="45718" rIns="91435" bIns="45718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35" tIns="45718" rIns="91435" bIns="45718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4"/>
            <a:ext cx="2971800" cy="458787"/>
          </a:xfrm>
          <a:prstGeom prst="rect">
            <a:avLst/>
          </a:prstGeom>
        </p:spPr>
        <p:txBody>
          <a:bodyPr vert="horz" lIns="91435" tIns="45718" rIns="91435" bIns="45718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4"/>
            <a:ext cx="2971800" cy="458787"/>
          </a:xfrm>
          <a:prstGeom prst="rect">
            <a:avLst/>
          </a:prstGeom>
        </p:spPr>
        <p:txBody>
          <a:bodyPr vert="horz" lIns="91435" tIns="45718" rIns="91435" bIns="45718" rtlCol="0" anchor="b"/>
          <a:lstStyle>
            <a:lvl1pPr algn="r">
              <a:defRPr sz="1200"/>
            </a:lvl1pPr>
          </a:lstStyle>
          <a:p>
            <a:fld id="{6319DB23-573F-4C71-BB24-19F8F211EC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84797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624138" y="1162050"/>
            <a:ext cx="1762125" cy="31369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C3AA957-8384-EA41-99C1-28AD808CE56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386077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84829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1681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43439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14372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9021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92755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68411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91063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63754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98021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7650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2708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E04E2817-D774-E827-49EE-9FF0C68DA3CD}"/>
              </a:ext>
            </a:extLst>
          </p:cNvPr>
          <p:cNvSpPr txBox="1"/>
          <p:nvPr/>
        </p:nvSpPr>
        <p:spPr>
          <a:xfrm>
            <a:off x="3235891" y="3108102"/>
            <a:ext cx="6074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CD19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582C32A-C29A-222D-24EA-2AC17D5E00E2}"/>
              </a:ext>
            </a:extLst>
          </p:cNvPr>
          <p:cNvSpPr txBox="1"/>
          <p:nvPr/>
        </p:nvSpPr>
        <p:spPr>
          <a:xfrm>
            <a:off x="3519865" y="3108102"/>
            <a:ext cx="6044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CD3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872175A-F661-1391-EC61-AF62D5A324BE}"/>
              </a:ext>
            </a:extLst>
          </p:cNvPr>
          <p:cNvSpPr txBox="1"/>
          <p:nvPr/>
        </p:nvSpPr>
        <p:spPr>
          <a:xfrm>
            <a:off x="3895131" y="3108102"/>
            <a:ext cx="5816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CD33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2970FEA-9772-4827-D528-04A529C55F11}"/>
              </a:ext>
            </a:extLst>
          </p:cNvPr>
          <p:cNvSpPr txBox="1"/>
          <p:nvPr/>
        </p:nvSpPr>
        <p:spPr>
          <a:xfrm>
            <a:off x="1946486" y="3125364"/>
            <a:ext cx="7395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hu-CD45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69EEF87-2BF6-124E-7472-3D20AC6E5A59}"/>
              </a:ext>
            </a:extLst>
          </p:cNvPr>
          <p:cNvSpPr txBox="1"/>
          <p:nvPr/>
        </p:nvSpPr>
        <p:spPr>
          <a:xfrm rot="16200000">
            <a:off x="1005869" y="2123005"/>
            <a:ext cx="14829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% of all PBMCs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DB07224-2875-32B8-7E7F-220272DEF544}"/>
              </a:ext>
            </a:extLst>
          </p:cNvPr>
          <p:cNvSpPr txBox="1"/>
          <p:nvPr/>
        </p:nvSpPr>
        <p:spPr>
          <a:xfrm>
            <a:off x="1238444" y="1300214"/>
            <a:ext cx="1653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15DD532-A3E6-4639-1252-5C15DD8E0DD1}"/>
              </a:ext>
            </a:extLst>
          </p:cNvPr>
          <p:cNvSpPr txBox="1"/>
          <p:nvPr/>
        </p:nvSpPr>
        <p:spPr>
          <a:xfrm>
            <a:off x="2536032" y="1320078"/>
            <a:ext cx="1653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2BCD079F-A929-B217-6733-36CA03143F8C}"/>
              </a:ext>
            </a:extLst>
          </p:cNvPr>
          <p:cNvSpPr txBox="1"/>
          <p:nvPr/>
        </p:nvSpPr>
        <p:spPr>
          <a:xfrm rot="16200000">
            <a:off x="2141593" y="2117890"/>
            <a:ext cx="15884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% of all hu-CD45+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7AAB7A4C-FA43-BC64-E0D3-C208B3226B2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2694" t="13135" r="37312" b="17066"/>
          <a:stretch/>
        </p:blipFill>
        <p:spPr>
          <a:xfrm>
            <a:off x="2985692" y="1406193"/>
            <a:ext cx="1462484" cy="1792794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28583B76-6919-6BCC-2B1D-0B5B68C340CD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39373" t="11972" r="45826" b="17103"/>
          <a:stretch/>
        </p:blipFill>
        <p:spPr>
          <a:xfrm>
            <a:off x="1748408" y="1324702"/>
            <a:ext cx="766191" cy="1877688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100103DE-5924-188C-D86F-28C98C99F5BB}"/>
              </a:ext>
            </a:extLst>
          </p:cNvPr>
          <p:cNvSpPr txBox="1"/>
          <p:nvPr/>
        </p:nvSpPr>
        <p:spPr>
          <a:xfrm>
            <a:off x="205878" y="3548417"/>
            <a:ext cx="6515100" cy="93871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145540" algn="l"/>
              </a:tabLst>
            </a:pPr>
            <a:r>
              <a:rPr lang="en-US" sz="1100" b="1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Figure S3</a:t>
            </a:r>
            <a:r>
              <a:rPr lang="en-US" sz="11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. </a:t>
            </a:r>
            <a:r>
              <a:rPr lang="en-US" sz="1100" b="1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Reconstitution with huCD45+ cells is verified prior to tumor implantation</a:t>
            </a:r>
            <a:r>
              <a:rPr lang="en-US" sz="11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. </a:t>
            </a:r>
            <a:r>
              <a:rPr lang="en-US" sz="11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Immunophenotyping for human CD45 was performed on peripheral blood mononuclear cells isolated from humanized mice prior to tumor implantation. The %hu-CD45+ represents the % of all PBMCs that express human CD45 (versus mouse CD45). Error bars represent standar</a:t>
            </a:r>
            <a:r>
              <a:rPr lang="en-US" sz="1100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d deviation. n = 36 humanized mouse peripheral blood samples. </a:t>
            </a:r>
            <a:endParaRPr lang="en-US" sz="11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176457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9ef9f489-e0a0-4eeb-87cc-3a526112fd0d}" enabled="0" method="" siteId="{9ef9f489-e0a0-4eeb-87cc-3a526112fd0d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85</Words>
  <Application>Microsoft Office PowerPoint</Application>
  <PresentationFormat>Widescreen</PresentationFormat>
  <Paragraphs>1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ley, Jessica</dc:creator>
  <cp:lastModifiedBy>Bailey, Kelly Margaret</cp:lastModifiedBy>
  <cp:revision>5</cp:revision>
  <cp:lastPrinted>2025-05-16T17:21:58Z</cp:lastPrinted>
  <dcterms:created xsi:type="dcterms:W3CDTF">2024-03-08T16:05:53Z</dcterms:created>
  <dcterms:modified xsi:type="dcterms:W3CDTF">2025-07-22T15:14:55Z</dcterms:modified>
</cp:coreProperties>
</file>